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fld id="{C99BCCB1-455A-46BF-AC8E-49CB14EADDCD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fld id="{9DA54472-3E53-447A-8B5A-2EE09D28674D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7D414-8DFC-4C63-8C15-871DA17A85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FC87E-4382-40AC-9681-81BC7C9D8E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209C5-6BDD-485B-B1D9-7143567B83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E3447-C811-4B08-B69D-0FB151DC84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1CCDD5-C19A-4D2D-8AA6-776C639836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1F90F-3B17-49B8-A788-EE4E896C26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FB658-EAA1-4755-9266-A5850D1395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A3F8E-F168-48B9-888D-3D62FDBD1B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B9174-A2FC-4783-A460-2155CD5335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01AEE-A256-4C7B-B521-C7A0AFC176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9D455-54E2-45CC-B9ED-0E92260B1F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77248-BDFA-48EF-B070-A6852B7D34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marL="357120" indent="-35712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76160" indent="-29844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197000" indent="-23832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674720" indent="-23796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52800" indent="-2383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52800" indent="-2383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52800" indent="-23832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1800"/>
            <a:ext cx="1600200" cy="52380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  <a:defRPr b="0" lang="de-DE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de-DE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1800"/>
            <a:ext cx="2171520" cy="52380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1800"/>
            <a:ext cx="1600200" cy="52380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  <a:defRPr b="0" lang="de-DE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fld id="{CC9F56CD-CCA9-4417-BF28-0CF349B56D20}" type="slidenum">
              <a:rPr b="0" lang="de-DE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01" descr=""/>
          <p:cNvPicPr/>
          <p:nvPr/>
        </p:nvPicPr>
        <p:blipFill>
          <a:blip r:embed="rId1"/>
          <a:stretch/>
        </p:blipFill>
        <p:spPr>
          <a:xfrm>
            <a:off x="952560" y="5027760"/>
            <a:ext cx="4887720" cy="29764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2" descr=""/>
          <p:cNvPicPr/>
          <p:nvPr/>
        </p:nvPicPr>
        <p:blipFill>
          <a:blip r:embed="rId2"/>
          <a:stretch/>
        </p:blipFill>
        <p:spPr>
          <a:xfrm>
            <a:off x="1015920" y="1633680"/>
            <a:ext cx="4824360" cy="2976480"/>
          </a:xfrm>
          <a:prstGeom prst="rect">
            <a:avLst/>
          </a:prstGeom>
          <a:ln w="0">
            <a:noFill/>
          </a:ln>
        </p:spPr>
      </p:pic>
      <p:sp>
        <p:nvSpPr>
          <p:cNvPr id="50" name="TextBox 2114"/>
          <p:cNvSpPr/>
          <p:nvPr/>
        </p:nvSpPr>
        <p:spPr>
          <a:xfrm>
            <a:off x="2608560" y="7923240"/>
            <a:ext cx="1989720" cy="38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1900" spc="-1" strike="noStrike">
                <a:solidFill>
                  <a:srgbClr val="000000"/>
                </a:solidFill>
                <a:latin typeface="Calibri"/>
              </a:rPr>
              <a:t>Retention time (s)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02"/>
          <p:cNvSpPr/>
          <p:nvPr/>
        </p:nvSpPr>
        <p:spPr>
          <a:xfrm>
            <a:off x="2608560" y="4538520"/>
            <a:ext cx="1989720" cy="38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1900" spc="-1" strike="noStrike">
                <a:solidFill>
                  <a:srgbClr val="000000"/>
                </a:solidFill>
                <a:latin typeface="Calibri"/>
              </a:rPr>
              <a:t>Retention time (s)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03"/>
          <p:cNvSpPr/>
          <p:nvPr/>
        </p:nvSpPr>
        <p:spPr>
          <a:xfrm rot="16200000">
            <a:off x="-170280" y="6246000"/>
            <a:ext cx="1823400" cy="38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1900" spc="-1" strike="noStrike">
                <a:solidFill>
                  <a:srgbClr val="000000"/>
                </a:solidFill>
                <a:latin typeface="Calibri"/>
              </a:rPr>
              <a:t>Abundance </a:t>
            </a:r>
            <a:r>
              <a:rPr b="0" lang="de-DE" sz="1900" spc="-1" strike="noStrike">
                <a:solidFill>
                  <a:srgbClr val="000000"/>
                </a:solidFill>
                <a:latin typeface="Calibri"/>
              </a:rPr>
              <a:t>(TIC)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04"/>
          <p:cNvSpPr/>
          <p:nvPr/>
        </p:nvSpPr>
        <p:spPr>
          <a:xfrm rot="16200000">
            <a:off x="-417240" y="2844720"/>
            <a:ext cx="2317320" cy="38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1900" spc="-1" strike="noStrike">
                <a:solidFill>
                  <a:srgbClr val="000000"/>
                </a:solidFill>
                <a:latin typeface="Calibri"/>
              </a:rPr>
              <a:t>Abundance</a:t>
            </a:r>
            <a:r>
              <a:rPr b="0" lang="de-DE" sz="1900" spc="-1" strike="noStrike">
                <a:solidFill>
                  <a:srgbClr val="000000"/>
                </a:solidFill>
                <a:latin typeface="Calibri"/>
              </a:rPr>
              <a:t> (m/z 361)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07"/>
          <p:cNvSpPr/>
          <p:nvPr/>
        </p:nvSpPr>
        <p:spPr>
          <a:xfrm>
            <a:off x="519840" y="1382760"/>
            <a:ext cx="365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08"/>
          <p:cNvSpPr/>
          <p:nvPr/>
        </p:nvSpPr>
        <p:spPr>
          <a:xfrm>
            <a:off x="520560" y="4764240"/>
            <a:ext cx="35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Straight Arrow Connector 2116"/>
          <p:cNvCxnSpPr/>
          <p:nvPr/>
        </p:nvCxnSpPr>
        <p:spPr>
          <a:xfrm>
            <a:off x="2752200" y="7105680"/>
            <a:ext cx="1080" cy="27324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57" name="TextBox 111"/>
          <p:cNvSpPr/>
          <p:nvPr/>
        </p:nvSpPr>
        <p:spPr>
          <a:xfrm>
            <a:off x="4067640" y="2363760"/>
            <a:ext cx="808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sucro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12"/>
          <p:cNvSpPr/>
          <p:nvPr/>
        </p:nvSpPr>
        <p:spPr>
          <a:xfrm>
            <a:off x="4223880" y="3773520"/>
            <a:ext cx="1299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l-GR" sz="1600" spc="-1" strike="noStrike">
                <a:solidFill>
                  <a:srgbClr val="000000"/>
                </a:solidFill>
                <a:latin typeface="Calibri"/>
              </a:rPr>
              <a:t>α,α-</a:t>
            </a:r>
            <a:r>
              <a:rPr b="0" lang="de-DE" sz="1600" spc="-1" strike="noStrike">
                <a:solidFill>
                  <a:srgbClr val="000000"/>
                </a:solidFill>
                <a:latin typeface="Calibri"/>
              </a:rPr>
              <a:t>trehalo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104" descr=""/>
          <p:cNvPicPr/>
          <p:nvPr/>
        </p:nvPicPr>
        <p:blipFill>
          <a:blip r:embed="rId3"/>
          <a:stretch/>
        </p:blipFill>
        <p:spPr>
          <a:xfrm>
            <a:off x="1590840" y="1817640"/>
            <a:ext cx="1726920" cy="2360520"/>
          </a:xfrm>
          <a:prstGeom prst="rect">
            <a:avLst/>
          </a:prstGeom>
          <a:ln w="0">
            <a:noFill/>
          </a:ln>
        </p:spPr>
      </p:pic>
      <p:cxnSp>
        <p:nvCxnSpPr>
          <p:cNvPr id="60" name="Straight Arrow Connector 115"/>
          <p:cNvCxnSpPr/>
          <p:nvPr/>
        </p:nvCxnSpPr>
        <p:spPr>
          <a:xfrm>
            <a:off x="2368080" y="3502080"/>
            <a:ext cx="1080" cy="2721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1" name="TextBox 116"/>
          <p:cNvSpPr/>
          <p:nvPr/>
        </p:nvSpPr>
        <p:spPr>
          <a:xfrm rot="16200000">
            <a:off x="2119680" y="2280240"/>
            <a:ext cx="102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α,α-</a:t>
            </a:r>
            <a:r>
              <a:rPr b="0" lang="de-DE" sz="1200" spc="-1" strike="noStrike">
                <a:solidFill>
                  <a:srgbClr val="000000"/>
                </a:solidFill>
                <a:latin typeface="Calibri"/>
              </a:rPr>
              <a:t>trehal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9T14:04:41Z</dcterms:created>
  <dc:creator>Joachim Kopka</dc:creator>
  <dc:description/>
  <dc:language>en-US</dc:language>
  <cp:lastModifiedBy>Windows User</cp:lastModifiedBy>
  <dcterms:modified xsi:type="dcterms:W3CDTF">2015-08-18T09:39:06Z</dcterms:modified>
  <cp:revision>92</cp:revision>
  <dc:subject/>
  <dc:title>Slide 1</dc:title>
</cp:coreProperties>
</file>